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.png" ContentType="image/png"/>
  <Override PartName="/ppt/media/image2.pct" ContentType="image/x-pict"/>
  <Override PartName="/ppt/media/image3.pct" ContentType="image/x-pict"/>
  <Override PartName="/ppt/media/image4.pct" ContentType="image/x-pic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271344-7AB8-4554-9752-99381FFDECB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8A4949-841D-4A5B-B2F0-FBE096BE04D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75735F-9BD9-4124-B62C-EECD1E78446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1BCAA0-1845-4799-BA82-E569D0BBD96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46A3BD-C55C-46C2-A3C1-68CFABD6C97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964B93-0141-462E-B45C-8371176241F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3986C7-1148-48AF-893B-967E3D7713C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9745E9-B11A-4E07-A4B6-CAA65AD50A8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BFA9B8-2E90-4898-8223-E0A454791A2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374FBE-C39C-4858-9176-638632CAF67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732FD2-762C-4B31-AF18-BF222C29CB4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E9A6D0-9138-4CF7-AAA9-0D0242EBB4E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C2F5904-5A98-4FB3-956B-ABF208A6D986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image" Target="../media/image2.pct"/><Relationship Id="rId4" Type="http://schemas.openxmlformats.org/officeDocument/2006/relationships/slideLayout" Target="../slideLayouts/slideLayout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pct"/><Relationship Id="rId2" Type="http://schemas.openxmlformats.org/officeDocument/2006/relationships/slideLayout" Target="../slideLayouts/slideLayout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4.pct"/><Relationship Id="rId2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0" y="1600200"/>
          <a:ext cx="2489040" cy="518148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0" y="1600200"/>
                    <a:ext cx="2489040" cy="51814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pic>
        <p:nvPicPr>
          <p:cNvPr id="43" name="" descr=""/>
          <p:cNvPicPr/>
          <p:nvPr/>
        </p:nvPicPr>
        <p:blipFill>
          <a:blip r:embed="rId3"/>
          <a:stretch/>
        </p:blipFill>
        <p:spPr>
          <a:xfrm>
            <a:off x="1981080" y="1239840"/>
            <a:ext cx="7162920" cy="5541840"/>
          </a:xfrm>
          <a:prstGeom prst="rect">
            <a:avLst/>
          </a:prstGeom>
          <a:ln w="0">
            <a:noFill/>
          </a:ln>
        </p:spPr>
      </p:pic>
      <p:sp>
        <p:nvSpPr>
          <p:cNvPr id="44" name=""/>
          <p:cNvSpPr/>
          <p:nvPr/>
        </p:nvSpPr>
        <p:spPr>
          <a:xfrm>
            <a:off x="1983240" y="471600"/>
            <a:ext cx="4366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551520" y="471600"/>
            <a:ext cx="4366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5040" y="44280"/>
            <a:ext cx="2183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upplement Figure 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4827240" y="152280"/>
            <a:ext cx="408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Comparison of Enrichment levels in GO-BP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762120" y="1143000"/>
            <a:ext cx="793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ll list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2439360" y="638280"/>
            <a:ext cx="118656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llN_allPD/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mN_mPD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" descr=""/>
          <p:cNvPicPr/>
          <p:nvPr/>
        </p:nvPicPr>
        <p:blipFill>
          <a:blip r:embed="rId1"/>
          <a:stretch/>
        </p:blipFill>
        <p:spPr>
          <a:xfrm>
            <a:off x="914400" y="1157400"/>
            <a:ext cx="6324480" cy="5700600"/>
          </a:xfrm>
          <a:prstGeom prst="rect">
            <a:avLst/>
          </a:prstGeom>
          <a:ln w="0">
            <a:noFill/>
          </a:ln>
        </p:spPr>
      </p:pic>
      <p:sp>
        <p:nvSpPr>
          <p:cNvPr id="51" name=""/>
          <p:cNvSpPr/>
          <p:nvPr/>
        </p:nvSpPr>
        <p:spPr>
          <a:xfrm>
            <a:off x="459000" y="457200"/>
            <a:ext cx="98064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B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(cont.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5040" y="44280"/>
            <a:ext cx="2183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upplement Figure 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1372680" y="533520"/>
            <a:ext cx="118656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llN_allPD/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mN_mPD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4879800" y="152280"/>
            <a:ext cx="408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Comparison of Enrichment levels in GO-BP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5" name="" descr=""/>
          <p:cNvPicPr/>
          <p:nvPr/>
        </p:nvPicPr>
        <p:blipFill>
          <a:blip r:embed="rId1"/>
          <a:stretch/>
        </p:blipFill>
        <p:spPr>
          <a:xfrm>
            <a:off x="533520" y="1104840"/>
            <a:ext cx="7696080" cy="2838600"/>
          </a:xfrm>
          <a:prstGeom prst="rect">
            <a:avLst/>
          </a:prstGeom>
          <a:ln w="0">
            <a:noFill/>
          </a:ln>
        </p:spPr>
      </p:pic>
      <p:sp>
        <p:nvSpPr>
          <p:cNvPr id="56" name=""/>
          <p:cNvSpPr/>
          <p:nvPr/>
        </p:nvSpPr>
        <p:spPr>
          <a:xfrm>
            <a:off x="154440" y="457200"/>
            <a:ext cx="4366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610560" y="457200"/>
            <a:ext cx="118656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llN_allPD/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fN_fPD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4879800" y="152280"/>
            <a:ext cx="4085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Comparison of Enrichment levels in GO-BP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5040" y="44280"/>
            <a:ext cx="2183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upplement Figure 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2-19T04:04:12Z</dcterms:created>
  <dc:creator>Kai Sonntag</dc:creator>
  <dc:description/>
  <dc:language>en-US</dc:language>
  <cp:lastModifiedBy>Kai Sonntag</cp:lastModifiedBy>
  <dcterms:modified xsi:type="dcterms:W3CDTF">2009-09-07T21:27:51Z</dcterms:modified>
  <cp:revision>22</cp:revision>
  <dc:subject/>
  <dc:title>PowerPoint Presentation</dc:title>
</cp:coreProperties>
</file>